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atsum\Dropbox\Karolinska\HMS\Near%20miss%20and%20perinatal%20death%20paper\near%20miss%20and%20stillbirths%202017-5%20(after%20first%20draft)2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atsum\Dropbox\Karolinska\HMS\Near%20miss%20and%20perinatal%20death%20paper\near%20miss%20and%20stillbirths%202017-5%20(after%20first%20draft)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5358705161854769E-2"/>
          <c:y val="2.5428331875182269E-2"/>
          <c:w val="0.91241907261592314"/>
          <c:h val="0.7365746327163650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2!$I$2</c:f>
              <c:strCache>
                <c:ptCount val="1"/>
                <c:pt idx="0">
                  <c:v>Condition present at arrival or within 12 hr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2!$B$3:$B$9</c:f>
              <c:strCache>
                <c:ptCount val="7"/>
                <c:pt idx="0">
                  <c:v>Coagulation</c:v>
                </c:pt>
                <c:pt idx="1">
                  <c:v>Cardiovascular</c:v>
                </c:pt>
                <c:pt idx="2">
                  <c:v>Respiratory</c:v>
                </c:pt>
                <c:pt idx="3">
                  <c:v>Uterine</c:v>
                </c:pt>
                <c:pt idx="4">
                  <c:v>Renal </c:v>
                </c:pt>
                <c:pt idx="5">
                  <c:v>Neurologic</c:v>
                </c:pt>
                <c:pt idx="6">
                  <c:v>Hepatic</c:v>
                </c:pt>
              </c:strCache>
            </c:strRef>
          </c:cat>
          <c:val>
            <c:numRef>
              <c:f>Sheet2!$I$3:$I$9</c:f>
              <c:numCache>
                <c:formatCode>General</c:formatCode>
                <c:ptCount val="7"/>
                <c:pt idx="0">
                  <c:v>353</c:v>
                </c:pt>
                <c:pt idx="1">
                  <c:v>305</c:v>
                </c:pt>
                <c:pt idx="2">
                  <c:v>161</c:v>
                </c:pt>
                <c:pt idx="3">
                  <c:v>96</c:v>
                </c:pt>
                <c:pt idx="4">
                  <c:v>66</c:v>
                </c:pt>
                <c:pt idx="5">
                  <c:v>56</c:v>
                </c:pt>
                <c:pt idx="6">
                  <c:v>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87-4834-A5D9-EAAB0C28C774}"/>
            </c:ext>
          </c:extLst>
        </c:ser>
        <c:ser>
          <c:idx val="1"/>
          <c:order val="1"/>
          <c:tx>
            <c:strRef>
              <c:f>Sheet2!$J$2</c:f>
              <c:strCache>
                <c:ptCount val="1"/>
                <c:pt idx="0">
                  <c:v>Developed after 12 hour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2!$B$3:$B$9</c:f>
              <c:strCache>
                <c:ptCount val="7"/>
                <c:pt idx="0">
                  <c:v>Coagulation</c:v>
                </c:pt>
                <c:pt idx="1">
                  <c:v>Cardiovascular</c:v>
                </c:pt>
                <c:pt idx="2">
                  <c:v>Respiratory</c:v>
                </c:pt>
                <c:pt idx="3">
                  <c:v>Uterine</c:v>
                </c:pt>
                <c:pt idx="4">
                  <c:v>Renal </c:v>
                </c:pt>
                <c:pt idx="5">
                  <c:v>Neurologic</c:v>
                </c:pt>
                <c:pt idx="6">
                  <c:v>Hepatic</c:v>
                </c:pt>
              </c:strCache>
            </c:strRef>
          </c:cat>
          <c:val>
            <c:numRef>
              <c:f>Sheet2!$J$3:$J$9</c:f>
              <c:numCache>
                <c:formatCode>General</c:formatCode>
                <c:ptCount val="7"/>
                <c:pt idx="0">
                  <c:v>16</c:v>
                </c:pt>
                <c:pt idx="1">
                  <c:v>16</c:v>
                </c:pt>
                <c:pt idx="2">
                  <c:v>12</c:v>
                </c:pt>
                <c:pt idx="3">
                  <c:v>3</c:v>
                </c:pt>
                <c:pt idx="4">
                  <c:v>2</c:v>
                </c:pt>
                <c:pt idx="5">
                  <c:v>3</c:v>
                </c:pt>
                <c:pt idx="6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587-4834-A5D9-EAAB0C28C774}"/>
            </c:ext>
          </c:extLst>
        </c:ser>
        <c:ser>
          <c:idx val="2"/>
          <c:order val="2"/>
          <c:tx>
            <c:strRef>
              <c:f>Sheet2!$K$2</c:f>
              <c:strCache>
                <c:ptCount val="1"/>
                <c:pt idx="0">
                  <c:v>Not known when developed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2!$B$3:$B$9</c:f>
              <c:strCache>
                <c:ptCount val="7"/>
                <c:pt idx="0">
                  <c:v>Coagulation</c:v>
                </c:pt>
                <c:pt idx="1">
                  <c:v>Cardiovascular</c:v>
                </c:pt>
                <c:pt idx="2">
                  <c:v>Respiratory</c:v>
                </c:pt>
                <c:pt idx="3">
                  <c:v>Uterine</c:v>
                </c:pt>
                <c:pt idx="4">
                  <c:v>Renal </c:v>
                </c:pt>
                <c:pt idx="5">
                  <c:v>Neurologic</c:v>
                </c:pt>
                <c:pt idx="6">
                  <c:v>Hepatic</c:v>
                </c:pt>
              </c:strCache>
            </c:strRef>
          </c:cat>
          <c:val>
            <c:numRef>
              <c:f>Sheet2!$K$3:$K$9</c:f>
              <c:numCache>
                <c:formatCode>General</c:formatCode>
                <c:ptCount val="7"/>
                <c:pt idx="0">
                  <c:v>4</c:v>
                </c:pt>
                <c:pt idx="1">
                  <c:v>2</c:v>
                </c:pt>
                <c:pt idx="2">
                  <c:v>2</c:v>
                </c:pt>
                <c:pt idx="3">
                  <c:v>42</c:v>
                </c:pt>
                <c:pt idx="4">
                  <c:v>2</c:v>
                </c:pt>
                <c:pt idx="5">
                  <c:v>3</c:v>
                </c:pt>
                <c:pt idx="6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587-4834-A5D9-EAAB0C28C7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600410280"/>
        <c:axId val="600415528"/>
      </c:barChart>
      <c:catAx>
        <c:axId val="600410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0415528"/>
        <c:crosses val="autoZero"/>
        <c:auto val="1"/>
        <c:lblAlgn val="ctr"/>
        <c:lblOffset val="100"/>
        <c:noMultiLvlLbl val="0"/>
      </c:catAx>
      <c:valAx>
        <c:axId val="600415528"/>
        <c:scaling>
          <c:orientation val="minMax"/>
          <c:max val="37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04102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6921787155241956"/>
          <c:y val="1.9140675597368512E-2"/>
          <c:w val="0.52418722659667538"/>
          <c:h val="0.1579877515310586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8025371828521428E-2"/>
          <c:y val="5.0925925925925923E-2"/>
          <c:w val="0.92197462817147857"/>
          <c:h val="0.6945494313210849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2!$I$16</c:f>
              <c:strCache>
                <c:ptCount val="1"/>
                <c:pt idx="0">
                  <c:v>Condition present at arrival or within 12 hr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2!$B$17:$B$23</c:f>
              <c:strCache>
                <c:ptCount val="7"/>
                <c:pt idx="0">
                  <c:v>Coagulation</c:v>
                </c:pt>
                <c:pt idx="1">
                  <c:v>Cardiovascular</c:v>
                </c:pt>
                <c:pt idx="2">
                  <c:v>Respiratory</c:v>
                </c:pt>
                <c:pt idx="3">
                  <c:v>Uterine</c:v>
                </c:pt>
                <c:pt idx="4">
                  <c:v>Renal </c:v>
                </c:pt>
                <c:pt idx="5">
                  <c:v>Neurologic</c:v>
                </c:pt>
                <c:pt idx="6">
                  <c:v>Hepatic</c:v>
                </c:pt>
              </c:strCache>
            </c:strRef>
          </c:cat>
          <c:val>
            <c:numRef>
              <c:f>Sheet2!$I$17:$I$23</c:f>
              <c:numCache>
                <c:formatCode>General</c:formatCode>
                <c:ptCount val="7"/>
                <c:pt idx="0">
                  <c:v>682</c:v>
                </c:pt>
                <c:pt idx="1">
                  <c:v>1309</c:v>
                </c:pt>
                <c:pt idx="2">
                  <c:v>622</c:v>
                </c:pt>
                <c:pt idx="3">
                  <c:v>190</c:v>
                </c:pt>
                <c:pt idx="4">
                  <c:v>426</c:v>
                </c:pt>
                <c:pt idx="5">
                  <c:v>125</c:v>
                </c:pt>
                <c:pt idx="6">
                  <c:v>1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87C-498B-940D-55C93A3C7214}"/>
            </c:ext>
          </c:extLst>
        </c:ser>
        <c:ser>
          <c:idx val="1"/>
          <c:order val="1"/>
          <c:tx>
            <c:strRef>
              <c:f>Sheet2!$J$16</c:f>
              <c:strCache>
                <c:ptCount val="1"/>
                <c:pt idx="0">
                  <c:v>Developed after 12 hour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2!$B$17:$B$23</c:f>
              <c:strCache>
                <c:ptCount val="7"/>
                <c:pt idx="0">
                  <c:v>Coagulation</c:v>
                </c:pt>
                <c:pt idx="1">
                  <c:v>Cardiovascular</c:v>
                </c:pt>
                <c:pt idx="2">
                  <c:v>Respiratory</c:v>
                </c:pt>
                <c:pt idx="3">
                  <c:v>Uterine</c:v>
                </c:pt>
                <c:pt idx="4">
                  <c:v>Renal </c:v>
                </c:pt>
                <c:pt idx="5">
                  <c:v>Neurologic</c:v>
                </c:pt>
                <c:pt idx="6">
                  <c:v>Hepatic</c:v>
                </c:pt>
              </c:strCache>
            </c:strRef>
          </c:cat>
          <c:val>
            <c:numRef>
              <c:f>Sheet2!$J$17:$J$23</c:f>
              <c:numCache>
                <c:formatCode>General</c:formatCode>
                <c:ptCount val="7"/>
                <c:pt idx="0">
                  <c:v>20</c:v>
                </c:pt>
                <c:pt idx="1">
                  <c:v>72</c:v>
                </c:pt>
                <c:pt idx="2">
                  <c:v>42</c:v>
                </c:pt>
                <c:pt idx="3">
                  <c:v>5</c:v>
                </c:pt>
                <c:pt idx="4">
                  <c:v>10</c:v>
                </c:pt>
                <c:pt idx="5">
                  <c:v>8</c:v>
                </c:pt>
                <c:pt idx="6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87C-498B-940D-55C93A3C7214}"/>
            </c:ext>
          </c:extLst>
        </c:ser>
        <c:ser>
          <c:idx val="2"/>
          <c:order val="2"/>
          <c:tx>
            <c:strRef>
              <c:f>Sheet2!$K$16</c:f>
              <c:strCache>
                <c:ptCount val="1"/>
                <c:pt idx="0">
                  <c:v>Not known when developed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2!$B$17:$B$23</c:f>
              <c:strCache>
                <c:ptCount val="7"/>
                <c:pt idx="0">
                  <c:v>Coagulation</c:v>
                </c:pt>
                <c:pt idx="1">
                  <c:v>Cardiovascular</c:v>
                </c:pt>
                <c:pt idx="2">
                  <c:v>Respiratory</c:v>
                </c:pt>
                <c:pt idx="3">
                  <c:v>Uterine</c:v>
                </c:pt>
                <c:pt idx="4">
                  <c:v>Renal </c:v>
                </c:pt>
                <c:pt idx="5">
                  <c:v>Neurologic</c:v>
                </c:pt>
                <c:pt idx="6">
                  <c:v>Hepatic</c:v>
                </c:pt>
              </c:strCache>
            </c:strRef>
          </c:cat>
          <c:val>
            <c:numRef>
              <c:f>Sheet2!$K$17:$K$23</c:f>
              <c:numCache>
                <c:formatCode>General</c:formatCode>
                <c:ptCount val="7"/>
                <c:pt idx="0">
                  <c:v>37</c:v>
                </c:pt>
                <c:pt idx="1">
                  <c:v>30</c:v>
                </c:pt>
                <c:pt idx="2">
                  <c:v>36</c:v>
                </c:pt>
                <c:pt idx="3">
                  <c:v>91</c:v>
                </c:pt>
                <c:pt idx="4">
                  <c:v>39</c:v>
                </c:pt>
                <c:pt idx="5">
                  <c:v>40</c:v>
                </c:pt>
                <c:pt idx="6">
                  <c:v>4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87C-498B-940D-55C93A3C72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643510936"/>
        <c:axId val="643513232"/>
      </c:barChart>
      <c:catAx>
        <c:axId val="6435109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3513232"/>
        <c:crosses val="autoZero"/>
        <c:auto val="1"/>
        <c:lblAlgn val="ctr"/>
        <c:lblOffset val="100"/>
        <c:noMultiLvlLbl val="0"/>
      </c:catAx>
      <c:valAx>
        <c:axId val="643513232"/>
        <c:scaling>
          <c:orientation val="minMax"/>
          <c:max val="14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35109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0040638670166226"/>
          <c:y val="1.3888888888888888E-2"/>
          <c:w val="0.49640944881889765"/>
          <c:h val="0.1487284922717993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AF461-DA96-4B78-9E5B-327EDC4B8239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A90B1-F8B4-44CF-85F8-0C2D75F8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54527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AF461-DA96-4B78-9E5B-327EDC4B8239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A90B1-F8B4-44CF-85F8-0C2D75F8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85830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AF461-DA96-4B78-9E5B-327EDC4B8239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A90B1-F8B4-44CF-85F8-0C2D75F8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55571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AF461-DA96-4B78-9E5B-327EDC4B8239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A90B1-F8B4-44CF-85F8-0C2D75F8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41770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AF461-DA96-4B78-9E5B-327EDC4B8239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A90B1-F8B4-44CF-85F8-0C2D75F8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6329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AF461-DA96-4B78-9E5B-327EDC4B8239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A90B1-F8B4-44CF-85F8-0C2D75F8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78071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AF461-DA96-4B78-9E5B-327EDC4B8239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A90B1-F8B4-44CF-85F8-0C2D75F8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3114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AF461-DA96-4B78-9E5B-327EDC4B8239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A90B1-F8B4-44CF-85F8-0C2D75F8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39205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AF461-DA96-4B78-9E5B-327EDC4B8239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A90B1-F8B4-44CF-85F8-0C2D75F8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17781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AF461-DA96-4B78-9E5B-327EDC4B8239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A90B1-F8B4-44CF-85F8-0C2D75F8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522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3AF461-DA96-4B78-9E5B-327EDC4B8239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A90B1-F8B4-44CF-85F8-0C2D75F8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63610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3AF461-DA96-4B78-9E5B-327EDC4B8239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A90B1-F8B4-44CF-85F8-0C2D75F8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7492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Picture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49322418"/>
              </p:ext>
            </p:extLst>
          </p:nvPr>
        </p:nvGraphicFramePr>
        <p:xfrm>
          <a:off x="3526536" y="472313"/>
          <a:ext cx="4846320" cy="29324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0529808"/>
              </p:ext>
            </p:extLst>
          </p:nvPr>
        </p:nvGraphicFramePr>
        <p:xfrm>
          <a:off x="3551301" y="3404743"/>
          <a:ext cx="4796790" cy="30340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9858273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Office PowerPoint</Application>
  <PresentationFormat>Widescreen</PresentationFormat>
  <Paragraphs>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 Fitzpatrick</dc:creator>
  <cp:lastModifiedBy>S Fitzpatrick</cp:lastModifiedBy>
  <cp:revision>1</cp:revision>
  <dcterms:created xsi:type="dcterms:W3CDTF">2018-09-13T14:19:57Z</dcterms:created>
  <dcterms:modified xsi:type="dcterms:W3CDTF">2018-09-13T14:20:10Z</dcterms:modified>
</cp:coreProperties>
</file>